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99" d="100"/>
          <a:sy n="99" d="100"/>
        </p:scale>
        <p:origin x="-2320" y="-117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AA0E5-DD02-D742-95F8-AF52B346A63E}" type="datetimeFigureOut">
              <a:rPr lang="en-US" smtClean="0"/>
              <a:t>24/0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6F46-716A-1E4D-9637-D7297D3402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882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AA0E5-DD02-D742-95F8-AF52B346A63E}" type="datetimeFigureOut">
              <a:rPr lang="en-US" smtClean="0"/>
              <a:t>24/0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6F46-716A-1E4D-9637-D7297D3402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78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AA0E5-DD02-D742-95F8-AF52B346A63E}" type="datetimeFigureOut">
              <a:rPr lang="en-US" smtClean="0"/>
              <a:t>24/0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6F46-716A-1E4D-9637-D7297D3402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960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AA0E5-DD02-D742-95F8-AF52B346A63E}" type="datetimeFigureOut">
              <a:rPr lang="en-US" smtClean="0"/>
              <a:t>24/0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6F46-716A-1E4D-9637-D7297D3402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760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AA0E5-DD02-D742-95F8-AF52B346A63E}" type="datetimeFigureOut">
              <a:rPr lang="en-US" smtClean="0"/>
              <a:t>24/0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6F46-716A-1E4D-9637-D7297D3402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294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AA0E5-DD02-D742-95F8-AF52B346A63E}" type="datetimeFigureOut">
              <a:rPr lang="en-US" smtClean="0"/>
              <a:t>24/0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6F46-716A-1E4D-9637-D7297D3402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51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AA0E5-DD02-D742-95F8-AF52B346A63E}" type="datetimeFigureOut">
              <a:rPr lang="en-US" smtClean="0"/>
              <a:t>24/0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6F46-716A-1E4D-9637-D7297D3402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913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AA0E5-DD02-D742-95F8-AF52B346A63E}" type="datetimeFigureOut">
              <a:rPr lang="en-US" smtClean="0"/>
              <a:t>24/0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6F46-716A-1E4D-9637-D7297D3402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603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AA0E5-DD02-D742-95F8-AF52B346A63E}" type="datetimeFigureOut">
              <a:rPr lang="en-US" smtClean="0"/>
              <a:t>24/0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6F46-716A-1E4D-9637-D7297D3402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035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AA0E5-DD02-D742-95F8-AF52B346A63E}" type="datetimeFigureOut">
              <a:rPr lang="en-US" smtClean="0"/>
              <a:t>24/0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6F46-716A-1E4D-9637-D7297D3402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970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AA0E5-DD02-D742-95F8-AF52B346A63E}" type="datetimeFigureOut">
              <a:rPr lang="en-US" smtClean="0"/>
              <a:t>24/0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A6F46-716A-1E4D-9637-D7297D3402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085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3AA0E5-DD02-D742-95F8-AF52B346A63E}" type="datetimeFigureOut">
              <a:rPr lang="en-US" smtClean="0"/>
              <a:t>24/0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3A6F46-716A-1E4D-9637-D7297D3402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053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15391" y="1048051"/>
            <a:ext cx="1246642" cy="55399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224 fully conscious patients aged1-12 with temperature &gt;38.5 screened for enrollment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571745" y="2358395"/>
            <a:ext cx="1278467" cy="20774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91 had positive RDT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136703" y="2358395"/>
            <a:ext cx="1278467" cy="20774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94 had negative RDT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817841" y="1806932"/>
            <a:ext cx="1246642" cy="32316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185 met all inclusion criteria and gave consent</a:t>
            </a:r>
            <a:endParaRPr lang="en-US" sz="750" dirty="0">
              <a:latin typeface="Arial"/>
              <a:cs typeface="Arial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3472650" y="1590739"/>
            <a:ext cx="0" cy="212909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3855118" y="2130097"/>
            <a:ext cx="0" cy="228298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2136703" y="2807123"/>
            <a:ext cx="1278467" cy="65520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4 blood sample not collected</a:t>
            </a:r>
          </a:p>
          <a:p>
            <a:pPr algn="ctr"/>
            <a:r>
              <a:rPr lang="en-US" sz="750" dirty="0">
                <a:latin typeface="Arial"/>
                <a:cs typeface="Arial"/>
              </a:rPr>
              <a:t>2</a:t>
            </a:r>
            <a:r>
              <a:rPr lang="en-US" sz="750" dirty="0" smtClean="0">
                <a:latin typeface="Arial"/>
                <a:cs typeface="Arial"/>
              </a:rPr>
              <a:t> withdrew </a:t>
            </a:r>
            <a:endParaRPr lang="en-US" sz="750" dirty="0">
              <a:latin typeface="Arial"/>
              <a:cs typeface="Arial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2775937" y="2566144"/>
            <a:ext cx="0" cy="234618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3571745" y="2800762"/>
            <a:ext cx="1278467" cy="66941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3 blood sample not collected</a:t>
            </a:r>
          </a:p>
          <a:p>
            <a:pPr algn="ctr"/>
            <a:r>
              <a:rPr lang="en-US" sz="750" dirty="0" smtClean="0">
                <a:latin typeface="Arial"/>
                <a:cs typeface="Arial"/>
              </a:rPr>
              <a:t>4 had negative smears for malaria</a:t>
            </a:r>
          </a:p>
          <a:p>
            <a:pPr algn="ctr"/>
            <a:endParaRPr lang="en-US" sz="750" dirty="0" smtClean="0">
              <a:latin typeface="Arial"/>
              <a:cs typeface="Arial"/>
            </a:endParaRP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4210979" y="2562358"/>
            <a:ext cx="0" cy="238404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2136703" y="3723170"/>
            <a:ext cx="1278467" cy="32316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88 in non-malarial febrile illness group at day 0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571745" y="3727198"/>
            <a:ext cx="1278467" cy="32316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84 in uncomplicated malaria group at day 0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571745" y="4281620"/>
            <a:ext cx="1278467" cy="900246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30 patients did not attend follow up </a:t>
            </a:r>
          </a:p>
          <a:p>
            <a:pPr algn="ctr"/>
            <a:r>
              <a:rPr lang="en-US" sz="750" dirty="0" smtClean="0">
                <a:latin typeface="Arial"/>
                <a:cs typeface="Arial"/>
              </a:rPr>
              <a:t>2 died</a:t>
            </a:r>
          </a:p>
          <a:p>
            <a:pPr algn="ctr"/>
            <a:r>
              <a:rPr lang="en-US" sz="750" dirty="0">
                <a:latin typeface="Arial"/>
                <a:cs typeface="Arial"/>
              </a:rPr>
              <a:t>5</a:t>
            </a:r>
            <a:r>
              <a:rPr lang="en-US" sz="750" dirty="0" smtClean="0">
                <a:latin typeface="Arial"/>
                <a:cs typeface="Arial"/>
              </a:rPr>
              <a:t> had parasitaemia or fever at follow up</a:t>
            </a:r>
          </a:p>
          <a:p>
            <a:pPr algn="ctr"/>
            <a:r>
              <a:rPr lang="en-US" sz="750" dirty="0">
                <a:latin typeface="Arial"/>
                <a:cs typeface="Arial"/>
              </a:rPr>
              <a:t>6</a:t>
            </a:r>
            <a:r>
              <a:rPr lang="en-US" sz="750" dirty="0" smtClean="0">
                <a:latin typeface="Arial"/>
                <a:cs typeface="Arial"/>
              </a:rPr>
              <a:t> blood sample not collected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136703" y="4281620"/>
            <a:ext cx="1278467" cy="89280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33 did not attend follow up </a:t>
            </a:r>
          </a:p>
          <a:p>
            <a:pPr algn="ctr"/>
            <a:r>
              <a:rPr lang="en-US" sz="750" dirty="0" smtClean="0">
                <a:latin typeface="Arial"/>
                <a:cs typeface="Arial"/>
              </a:rPr>
              <a:t>2 had parasitaemia or fever at follow up</a:t>
            </a:r>
          </a:p>
          <a:p>
            <a:pPr algn="ctr"/>
            <a:r>
              <a:rPr lang="en-US" sz="750" dirty="0" smtClean="0">
                <a:latin typeface="Arial"/>
                <a:cs typeface="Arial"/>
              </a:rPr>
              <a:t>6 blood sample not collected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571745" y="5416123"/>
            <a:ext cx="1278467" cy="32316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41 patients followed up to 1 month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136703" y="5416123"/>
            <a:ext cx="1278467" cy="32316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47 patients followed up to 1 month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817841" y="565982"/>
            <a:ext cx="1246642" cy="32316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b="1" dirty="0" smtClean="0">
                <a:latin typeface="Arial"/>
                <a:cs typeface="Arial"/>
              </a:rPr>
              <a:t>Uncomplicated febrile illness</a:t>
            </a:r>
            <a:endParaRPr lang="en-US" sz="750" b="1" dirty="0">
              <a:latin typeface="Arial"/>
              <a:cs typeface="Arial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35207" y="565982"/>
            <a:ext cx="1246642" cy="20774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b="1" dirty="0" smtClean="0">
                <a:latin typeface="Arial"/>
                <a:cs typeface="Arial"/>
              </a:rPr>
              <a:t>Healthy controls</a:t>
            </a:r>
            <a:endParaRPr lang="en-US" sz="750" b="1" dirty="0">
              <a:latin typeface="Arial"/>
              <a:cs typeface="Ari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35207" y="1036741"/>
            <a:ext cx="1246642" cy="55399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39 well children attending routine surgery aged 1-12 screened for enrollment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35207" y="1797749"/>
            <a:ext cx="1246642" cy="32316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36 met all inclusion criteria and gave consent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35207" y="2343006"/>
            <a:ext cx="1246642" cy="32316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36 in healthy controls group day 0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35207" y="2849005"/>
            <a:ext cx="1246642" cy="20774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Not followed up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132419" y="567794"/>
            <a:ext cx="1246642" cy="20774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b="1" dirty="0" smtClean="0">
                <a:latin typeface="Arial"/>
                <a:cs typeface="Arial"/>
              </a:rPr>
              <a:t>Cerebral malaria</a:t>
            </a:r>
            <a:endParaRPr lang="en-US" sz="750" b="1" dirty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132419" y="1036741"/>
            <a:ext cx="1246642" cy="438582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43 comatose children aged 1-12 with cerebral malaria screened 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100594" y="1784648"/>
            <a:ext cx="1246642" cy="32316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18 met all inclusion criteria and gave consent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100594" y="4290436"/>
            <a:ext cx="1278467" cy="900246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4 patients did not attend follow up </a:t>
            </a:r>
          </a:p>
          <a:p>
            <a:pPr algn="ctr"/>
            <a:r>
              <a:rPr lang="en-US" sz="750" dirty="0">
                <a:latin typeface="Arial"/>
                <a:cs typeface="Arial"/>
              </a:rPr>
              <a:t>1</a:t>
            </a:r>
            <a:r>
              <a:rPr lang="en-US" sz="750" dirty="0" smtClean="0">
                <a:latin typeface="Arial"/>
                <a:cs typeface="Arial"/>
              </a:rPr>
              <a:t> died</a:t>
            </a:r>
          </a:p>
          <a:p>
            <a:pPr algn="ctr"/>
            <a:r>
              <a:rPr lang="en-US" sz="750" dirty="0">
                <a:latin typeface="Arial"/>
                <a:cs typeface="Arial"/>
              </a:rPr>
              <a:t>1</a:t>
            </a:r>
            <a:r>
              <a:rPr lang="en-US" sz="750" dirty="0" smtClean="0">
                <a:latin typeface="Arial"/>
                <a:cs typeface="Arial"/>
              </a:rPr>
              <a:t> had parasitaemia at follow up</a:t>
            </a:r>
          </a:p>
          <a:p>
            <a:pPr algn="ctr"/>
            <a:r>
              <a:rPr lang="en-US" sz="750" dirty="0">
                <a:latin typeface="Arial"/>
                <a:cs typeface="Arial"/>
              </a:rPr>
              <a:t>3</a:t>
            </a:r>
            <a:r>
              <a:rPr lang="en-US" sz="750" dirty="0" smtClean="0">
                <a:latin typeface="Arial"/>
                <a:cs typeface="Arial"/>
              </a:rPr>
              <a:t> blood samples not collected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100594" y="3723170"/>
            <a:ext cx="1278467" cy="32316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18 in cerebral malaria group at day 0</a:t>
            </a:r>
            <a:endParaRPr lang="en-US" sz="750" dirty="0">
              <a:latin typeface="Arial"/>
              <a:cs typeface="Arial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100594" y="5415206"/>
            <a:ext cx="1278467" cy="32316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750" dirty="0" smtClean="0">
                <a:latin typeface="Arial"/>
                <a:cs typeface="Arial"/>
              </a:rPr>
              <a:t>10 patients followed up to 1 month</a:t>
            </a:r>
            <a:endParaRPr lang="en-US" sz="750" dirty="0">
              <a:latin typeface="Arial"/>
              <a:cs typeface="Arial"/>
            </a:endParaRPr>
          </a:p>
        </p:txBody>
      </p:sp>
      <p:cxnSp>
        <p:nvCxnSpPr>
          <p:cNvPr id="53" name="Straight Arrow Connector 52"/>
          <p:cNvCxnSpPr/>
          <p:nvPr/>
        </p:nvCxnSpPr>
        <p:spPr>
          <a:xfrm>
            <a:off x="2775937" y="3470176"/>
            <a:ext cx="0" cy="238404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/>
          <p:nvPr/>
        </p:nvCxnSpPr>
        <p:spPr>
          <a:xfrm>
            <a:off x="4210979" y="3488794"/>
            <a:ext cx="0" cy="238404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>
            <a:off x="2769667" y="4043216"/>
            <a:ext cx="0" cy="238404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>
            <a:off x="4210979" y="4052032"/>
            <a:ext cx="0" cy="238404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/>
          <p:nvPr/>
        </p:nvCxnSpPr>
        <p:spPr>
          <a:xfrm>
            <a:off x="2769667" y="5177719"/>
            <a:ext cx="0" cy="238404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>
            <a:off x="4213780" y="5177719"/>
            <a:ext cx="0" cy="238404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>
            <a:off x="5781301" y="5177719"/>
            <a:ext cx="0" cy="238404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>
            <a:off x="5779567" y="4041180"/>
            <a:ext cx="0" cy="238404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/>
          <p:nvPr/>
        </p:nvCxnSpPr>
        <p:spPr>
          <a:xfrm>
            <a:off x="5778820" y="2107813"/>
            <a:ext cx="2481" cy="1600767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>
            <a:off x="5779567" y="1471537"/>
            <a:ext cx="1734" cy="313111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/>
          <p:cNvCxnSpPr/>
          <p:nvPr/>
        </p:nvCxnSpPr>
        <p:spPr>
          <a:xfrm>
            <a:off x="1124912" y="1590739"/>
            <a:ext cx="0" cy="193909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/>
          <p:cNvCxnSpPr/>
          <p:nvPr/>
        </p:nvCxnSpPr>
        <p:spPr>
          <a:xfrm>
            <a:off x="1119235" y="2130097"/>
            <a:ext cx="0" cy="193909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/>
          <p:cNvCxnSpPr/>
          <p:nvPr/>
        </p:nvCxnSpPr>
        <p:spPr>
          <a:xfrm>
            <a:off x="1119235" y="2655096"/>
            <a:ext cx="0" cy="193909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/>
          <p:cNvCxnSpPr/>
          <p:nvPr/>
        </p:nvCxnSpPr>
        <p:spPr>
          <a:xfrm>
            <a:off x="3087395" y="2130097"/>
            <a:ext cx="0" cy="228298"/>
          </a:xfrm>
          <a:prstGeom prst="straightConnector1">
            <a:avLst/>
          </a:prstGeom>
          <a:ln w="9525" cmpd="sng">
            <a:solidFill>
              <a:srgbClr val="00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287496" y="8914501"/>
            <a:ext cx="40728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/>
                <a:cs typeface="Arial"/>
              </a:rPr>
              <a:t>Supplemental figure </a:t>
            </a:r>
            <a:r>
              <a:rPr lang="en-US" sz="2000" b="1" dirty="0">
                <a:latin typeface="Arial"/>
                <a:cs typeface="Arial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2799555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6</TotalTime>
  <Words>217</Words>
  <Application>Microsoft Macintosh PowerPoint</Application>
  <PresentationFormat>A4 Paper (210x297 mm)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ST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Moxon</dc:creator>
  <cp:lastModifiedBy>Christopher Moxon</cp:lastModifiedBy>
  <cp:revision>9</cp:revision>
  <dcterms:created xsi:type="dcterms:W3CDTF">2012-10-14T20:51:05Z</dcterms:created>
  <dcterms:modified xsi:type="dcterms:W3CDTF">2013-06-24T17:10:13Z</dcterms:modified>
</cp:coreProperties>
</file>